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omments/comment1.xml" ContentType="application/vnd.openxmlformats-officedocument.presentationml.comments+xml"/>
  <Override PartName="/ppt/comments/comment2.xml" ContentType="application/vnd.openxmlformats-officedocument.presentationml.comment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12" r:id="rId2"/>
    <p:sldId id="259" r:id="rId3"/>
    <p:sldId id="341" r:id="rId4"/>
    <p:sldId id="344" r:id="rId5"/>
    <p:sldId id="342" r:id="rId6"/>
    <p:sldId id="343" r:id="rId7"/>
    <p:sldId id="257" r:id="rId8"/>
    <p:sldId id="305" r:id="rId9"/>
    <p:sldId id="306" r:id="rId10"/>
    <p:sldId id="307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uan huidong" initials="xh" lastIdx="2" clrIdx="0">
    <p:extLst>
      <p:ext uri="{19B8F6BF-5375-455C-9EA6-DF929625EA0E}">
        <p15:presenceInfo xmlns:p15="http://schemas.microsoft.com/office/powerpoint/2012/main" userId="68f23ac20ab25d3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808A8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76" autoAdjust="0"/>
  </p:normalViewPr>
  <p:slideViewPr>
    <p:cSldViewPr snapToGrid="0">
      <p:cViewPr varScale="1">
        <p:scale>
          <a:sx n="64" d="100"/>
          <a:sy n="64" d="100"/>
        </p:scale>
        <p:origin x="45" y="4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304694115136668E-2"/>
          <c:y val="0.10494273309541931"/>
          <c:w val="0.9223958880139983"/>
          <c:h val="0.7686803732866724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2296587926509183E-2"/>
                  <c:y val="-0.1174671916010498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B$3:$B$34</c:f>
              <c:numCache>
                <c:formatCode>General</c:formatCode>
                <c:ptCount val="32"/>
                <c:pt idx="0">
                  <c:v>1.42132832304784</c:v>
                </c:pt>
                <c:pt idx="1">
                  <c:v>2.6550118530647802</c:v>
                </c:pt>
                <c:pt idx="2">
                  <c:v>4.1285408570079403</c:v>
                </c:pt>
                <c:pt idx="3">
                  <c:v>2.5557319550134601</c:v>
                </c:pt>
                <c:pt idx="4">
                  <c:v>1.0793804076443601</c:v>
                </c:pt>
                <c:pt idx="5">
                  <c:v>2.02984937650124</c:v>
                </c:pt>
                <c:pt idx="6">
                  <c:v>2.6227329635247001</c:v>
                </c:pt>
                <c:pt idx="7">
                  <c:v>2.68694132538266</c:v>
                </c:pt>
                <c:pt idx="8">
                  <c:v>2.1929544455888101</c:v>
                </c:pt>
                <c:pt idx="9">
                  <c:v>0.98799140516552697</c:v>
                </c:pt>
                <c:pt idx="10">
                  <c:v>2.0473545842154199</c:v>
                </c:pt>
                <c:pt idx="11">
                  <c:v>1.36598261207759</c:v>
                </c:pt>
                <c:pt idx="12">
                  <c:v>3.6915054780202201</c:v>
                </c:pt>
                <c:pt idx="13">
                  <c:v>1.8704865320908399</c:v>
                </c:pt>
                <c:pt idx="14">
                  <c:v>1.05962072377515</c:v>
                </c:pt>
                <c:pt idx="15">
                  <c:v>1.64025796649009</c:v>
                </c:pt>
                <c:pt idx="16">
                  <c:v>1.05124586674076</c:v>
                </c:pt>
                <c:pt idx="17">
                  <c:v>1.47128924221928</c:v>
                </c:pt>
                <c:pt idx="18">
                  <c:v>-0.360645934105432</c:v>
                </c:pt>
                <c:pt idx="19">
                  <c:v>-2.9943475172957301</c:v>
                </c:pt>
                <c:pt idx="20">
                  <c:v>-1.8401041313867399</c:v>
                </c:pt>
                <c:pt idx="21">
                  <c:v>-1.77384156907561</c:v>
                </c:pt>
                <c:pt idx="22">
                  <c:v>-1.85497223868096</c:v>
                </c:pt>
                <c:pt idx="23">
                  <c:v>-1.7150570534517999</c:v>
                </c:pt>
                <c:pt idx="24">
                  <c:v>-2.0807239231729802</c:v>
                </c:pt>
                <c:pt idx="25">
                  <c:v>0.35033779073865001</c:v>
                </c:pt>
                <c:pt idx="26">
                  <c:v>-1.9795334358947601</c:v>
                </c:pt>
                <c:pt idx="27">
                  <c:v>-1.2321392005788401</c:v>
                </c:pt>
                <c:pt idx="28">
                  <c:v>-3.2516852851844802</c:v>
                </c:pt>
                <c:pt idx="29">
                  <c:v>-1.9860926452469301</c:v>
                </c:pt>
                <c:pt idx="30">
                  <c:v>-5.2032169516507896</c:v>
                </c:pt>
                <c:pt idx="31">
                  <c:v>-3.0609284548859201</c:v>
                </c:pt>
              </c:numCache>
            </c:numRef>
          </c:xVal>
          <c:yVal>
            <c:numRef>
              <c:f>Sheet1!$C$3:$C$34</c:f>
              <c:numCache>
                <c:formatCode>General</c:formatCode>
                <c:ptCount val="32"/>
                <c:pt idx="0">
                  <c:v>3.1077777777777778</c:v>
                </c:pt>
                <c:pt idx="1">
                  <c:v>1.4677777777777823</c:v>
                </c:pt>
                <c:pt idx="2">
                  <c:v>4.7872222222222227</c:v>
                </c:pt>
                <c:pt idx="3">
                  <c:v>5.4177777777777756</c:v>
                </c:pt>
                <c:pt idx="4">
                  <c:v>2.1005555555555531</c:v>
                </c:pt>
                <c:pt idx="5">
                  <c:v>2.6966666666666712</c:v>
                </c:pt>
                <c:pt idx="6">
                  <c:v>2.9927777777777806</c:v>
                </c:pt>
                <c:pt idx="7">
                  <c:v>2.2611111111111128</c:v>
                </c:pt>
                <c:pt idx="8">
                  <c:v>2.7444444444444445</c:v>
                </c:pt>
                <c:pt idx="9">
                  <c:v>2.2033333333333367</c:v>
                </c:pt>
                <c:pt idx="10">
                  <c:v>2.1344444444444441</c:v>
                </c:pt>
                <c:pt idx="11">
                  <c:v>0.39222222222222314</c:v>
                </c:pt>
                <c:pt idx="12">
                  <c:v>5.9877777777777732</c:v>
                </c:pt>
                <c:pt idx="13">
                  <c:v>2.5988888888888875</c:v>
                </c:pt>
                <c:pt idx="14">
                  <c:v>2.4700000000000006</c:v>
                </c:pt>
                <c:pt idx="15">
                  <c:v>2.3377777777777795</c:v>
                </c:pt>
                <c:pt idx="16">
                  <c:v>2.2033333333333323</c:v>
                </c:pt>
                <c:pt idx="17">
                  <c:v>1.5783333333333329</c:v>
                </c:pt>
                <c:pt idx="18">
                  <c:v>-0.66333333333333511</c:v>
                </c:pt>
                <c:pt idx="19">
                  <c:v>-1.0727777777777803</c:v>
                </c:pt>
                <c:pt idx="20">
                  <c:v>-2.6666666666666656</c:v>
                </c:pt>
                <c:pt idx="21">
                  <c:v>-1.9322222222222212</c:v>
                </c:pt>
                <c:pt idx="22">
                  <c:v>-1.6711111111111081</c:v>
                </c:pt>
                <c:pt idx="23">
                  <c:v>-0.61555555555555941</c:v>
                </c:pt>
                <c:pt idx="24">
                  <c:v>-2.6555555555555603</c:v>
                </c:pt>
                <c:pt idx="25">
                  <c:v>-0.89277777777778056</c:v>
                </c:pt>
                <c:pt idx="26">
                  <c:v>-1.6422222222222207</c:v>
                </c:pt>
                <c:pt idx="27">
                  <c:v>-1.068888888888889</c:v>
                </c:pt>
                <c:pt idx="28">
                  <c:v>-2.4844444444444465</c:v>
                </c:pt>
                <c:pt idx="29">
                  <c:v>-1.8833333333333353</c:v>
                </c:pt>
                <c:pt idx="30">
                  <c:v>-5.0527777777777771</c:v>
                </c:pt>
                <c:pt idx="31">
                  <c:v>-2.24833333333333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407-4F37-817A-60698BA06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0120592"/>
        <c:axId val="860116016"/>
      </c:scatterChart>
      <c:valAx>
        <c:axId val="860120592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60116016"/>
        <c:crosses val="autoZero"/>
        <c:crossBetween val="midCat"/>
      </c:valAx>
      <c:valAx>
        <c:axId val="8601160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860120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2700">
      <a:solidFill>
        <a:schemeClr val="tx1"/>
      </a:solidFill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2-03-07T09:52:53.823" idx="1">
    <p:pos x="10" y="10"/>
    <p:text>We have revised hyphen (-) to minus sign (−) in the figure.</p:text>
    <p:extLst>
      <p:ext uri="{C676402C-5697-4E1C-873F-D02D1690AC5C}">
        <p15:threadingInfo xmlns:p15="http://schemas.microsoft.com/office/powerpoint/2012/main" timeZoneBias="-480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2-03-07T09:55:36.171" idx="2">
    <p:pos x="10" y="10"/>
    <p:text>We have revised hyphen (-) to minus sign (−) in the figure.</p:text>
    <p:extLst>
      <p:ext uri="{C676402C-5697-4E1C-873F-D02D1690AC5C}">
        <p15:threadingInfo xmlns:p15="http://schemas.microsoft.com/office/powerpoint/2012/main" timeZoneBias="-48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ED364E-1506-4A86-923C-291A12A261D2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1B8334-D388-4AA1-A272-A52478E8E0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476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B8334-D388-4AA1-A272-A52478E8E04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7419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补充完整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AB1539-503A-4E64-99B8-25B8B43B6F25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789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C22E4F-6334-4CCB-8355-1B74DF8F9E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D0E1980-9240-46E3-AB0A-E41766B054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4AF355-411E-4C60-A49E-EC2035852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B888C7-0464-4336-8788-3FC44B240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1F2080-E86C-4745-86E2-EC4231D9D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020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EF4F37-A2FF-4A59-8042-4C9701002B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E0E48E0-98E7-4E2B-A36F-881E3090F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5B254C-4213-42E0-A0A9-DD0E0BB46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DE2D39-D689-4132-B220-060DCB4CC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11B0E6-6397-48DA-BB08-3CF378799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870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C95CBF0-A3B2-465E-A0EE-2D804F6B25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7543B22-7D38-4D80-B552-46F7406D4F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8198D2-3D20-4CB1-A6E6-76E3965BC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AB21E1-11B1-4890-85BE-2521AE8AD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B536FE-B80A-437E-818C-744A7D63E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0529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1E722E-47A9-4AE4-BC59-6F06E9B3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303C4B-F120-47AB-9AB5-0E9669C8AF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4011A2-BD70-4B8C-9279-D86096DD4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392C2D-FF97-448D-B605-04F443B08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8E80E4-D899-4B62-BC85-B6EC0C6A8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4841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DFED50-4662-4730-8DD7-DCF47FC3C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8B6192-08F3-41FE-BB23-408C42A0DA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F37829-396A-4F25-89B9-F1CE3CC67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F86B1A-7B01-4E11-9169-5581217D8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717C48-351E-4D25-82D2-6861A30D9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706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5FB40A-2A5E-47C8-9B30-C07E14AD8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804F6A-F5A7-4D20-9BC0-188763C3F3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3D1A287-5542-44A1-97D9-81BBFBDC57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BC1B2F-209A-4360-B697-C8181556B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77A773-6A11-4A84-B19B-D01E3A5FA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83498D-CE72-4E20-958F-FA9C52D5B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407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4C5C56-742E-434F-9BD7-E9854D6AB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8AB18C-16C0-4B5C-B1A4-E11857238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653CC0-6F6C-48AE-8611-278C7C6E91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F0C8623-84A2-470A-9011-B39EBBE64A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4598997-3EB3-4A1C-8ECB-7990D4F426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7529081-9B42-4FAA-BA83-02309BB32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D7F254A-EC12-4902-A750-DDF428B3F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6D77DC5-AA8D-4764-BA54-77ACFC8D9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6845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02566C-016C-4889-918C-D180512C6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97021FE-7E42-41F7-B16C-152D4A412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3F59E95-3C69-4612-BCCF-14485AE0F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D185409-8A59-4EA4-9C26-04A9CB003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618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BBE3356-CE3A-46A5-921E-5DC193EA9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7788BB1-D65B-409B-8C26-FC9995D01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E1963F6-EF50-4B3B-8017-46ED49535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7636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F1FD1C-36B4-4B85-A063-810A2FC9F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7136F5-9990-4567-9692-0869B10F71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3FF1FF-8D07-494D-BC8C-6030572389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3BE523-303D-4B51-99FD-6B00DF45C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0F79F97-52D8-4341-9A32-B8DE32BFF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B4055D-D670-4128-8D11-971422F6F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860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6CD452-DE3D-4DAF-AE71-99731BFF3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42E817D-C992-46CF-86DF-D9C1A698D6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394E851-0059-4E13-A358-EDC27F4418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B30980-7FBE-4AED-A4A3-6C4EEA3F3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4F64DC-F73A-4334-A0EF-4321C36B5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0E7511-1B42-4583-9474-82C3E61B9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136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8C838EB-7874-49DC-A314-69BBCD849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5DD2CA5-3F70-4C25-84E2-EE8C79D9E4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343332-BF46-429D-9748-C259DF7644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76CD5-0FBD-4766-B1D3-1F767EFAC857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629F8D-1489-48A6-AF8E-B203288A17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15227D-A763-42CF-A287-E880DA7EB1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EB074-F2BA-4030-9C20-F9765962CE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627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m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2.xm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F6B8993-B4E1-4611-99ED-74E6D50CA6D5}"/>
              </a:ext>
            </a:extLst>
          </p:cNvPr>
          <p:cNvSpPr txBox="1"/>
          <p:nvPr/>
        </p:nvSpPr>
        <p:spPr>
          <a:xfrm>
            <a:off x="1688309" y="3362671"/>
            <a:ext cx="75598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uan</a:t>
            </a:r>
            <a:r>
              <a:rPr kumimoji="0" lang="zh-CN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t al.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2E63C1E-C5CF-4EA7-ACE0-3AB91EA9BDAF}"/>
              </a:ext>
            </a:extLst>
          </p:cNvPr>
          <p:cNvSpPr txBox="1"/>
          <p:nvPr/>
        </p:nvSpPr>
        <p:spPr>
          <a:xfrm>
            <a:off x="1534602" y="1198927"/>
            <a:ext cx="9374588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ype of the Paper (Article)</a:t>
            </a:r>
          </a:p>
          <a:p>
            <a:pPr algn="just">
              <a:lnSpc>
                <a:spcPct val="150000"/>
              </a:lnSpc>
            </a:pP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95000"/>
              </a:lnSpc>
            </a:pPr>
            <a:r>
              <a:rPr lang="en-US" altLang="zh-CN" sz="1600" b="1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ey Soybean Seedlings Drought-Responsive Genes and Pathways Revealed by Comparative Transcriptome Analyses of Contrasting Two Cultivars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95000"/>
              </a:lnSpc>
            </a:pPr>
            <a:r>
              <a:rPr lang="en-US" altLang="zh-CN" sz="2800" b="1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2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3617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A004A40-E2CF-4FCD-9193-16F5139A4281}"/>
              </a:ext>
            </a:extLst>
          </p:cNvPr>
          <p:cNvSpPr txBox="1"/>
          <p:nvPr/>
        </p:nvSpPr>
        <p:spPr>
          <a:xfrm>
            <a:off x="2662942" y="1154964"/>
            <a:ext cx="501420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latin typeface="Palatino Linotype" panose="02040502050505030304" pitchFamily="18" charset="0"/>
                <a:ea typeface="等线" panose="02010600030101010101" pitchFamily="2" charset="-122"/>
              </a:rPr>
              <a:t>T</a:t>
            </a:r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</a:rPr>
              <a:t>able S4</a:t>
            </a:r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900" b="1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rimers used for quantitative real-time PCR.</a:t>
            </a:r>
            <a:endParaRPr lang="zh-CN" altLang="zh-CN" sz="900" b="1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A50B2191-69DE-4C42-836E-DDFF58CD43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6517188"/>
              </p:ext>
            </p:extLst>
          </p:nvPr>
        </p:nvGraphicFramePr>
        <p:xfrm>
          <a:off x="2763860" y="1513120"/>
          <a:ext cx="5880078" cy="3575677"/>
        </p:xfrm>
        <a:graphic>
          <a:graphicData uri="http://schemas.openxmlformats.org/drawingml/2006/table">
            <a:tbl>
              <a:tblPr firstRow="1" firstCol="1" bandRow="1"/>
              <a:tblGrid>
                <a:gridCol w="1748713">
                  <a:extLst>
                    <a:ext uri="{9D8B030D-6E8A-4147-A177-3AD203B41FA5}">
                      <a16:colId xmlns:a16="http://schemas.microsoft.com/office/drawing/2014/main" val="1568520019"/>
                    </a:ext>
                  </a:extLst>
                </a:gridCol>
                <a:gridCol w="4131365">
                  <a:extLst>
                    <a:ext uri="{9D8B030D-6E8A-4147-A177-3AD203B41FA5}">
                      <a16:colId xmlns:a16="http://schemas.microsoft.com/office/drawing/2014/main" val="856107880"/>
                    </a:ext>
                  </a:extLst>
                </a:gridCol>
              </a:tblGrid>
              <a:tr h="24433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quence of primer pairs (5'-3’)   F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8864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06G2489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8G1005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04G1701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GGAGGTTCAAAGTGGTG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CGGGTATCTGGATTCGGT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ATGACGGCACTGATGAA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TATAAGAAGAGGCAGTGGT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TTCTTCACACAACCCCA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GAACTAGACCCTGTGGC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58813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5G2501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CAAATGGTGTTGACGGT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GCTTAACGGAAGCCTC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5936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06G1670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AAGCCACAAGGATTAGA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TCTCAATCACAGGCACAG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720201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3G2799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TGGTACAGGACCAGACTC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GTCCAAGTGGCATAACG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4671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08G0690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GACACCAGAAGCACACG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CACCAACTTGCCACTGCT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411604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04G0796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AACGTGGCACTCTTCTT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TGACCCGGGTTTGACAG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530988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1G1312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AGATCTTCAGCAGCACCCT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GATCGGTAACGTGTCA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3269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7G1454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TACGGACGGAGTGATTCT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AAACGGAAGCTCTCCCC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34660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3G1299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TGCATTAGTGGGAGCAG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CGACAGTACTGAGGGAC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659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0G0547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AGTGGGGTGGAACTGGAA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TCCCCTGTCTTGCTGTC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567816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0G1566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CACCTTGTTGGCTGCTAC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CTGGTGGTCCAATCTCC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479263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3G1731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CACCAATCTCTGCGCTAT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TACGCCTAGCGAGTTGA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6955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7G1402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CTCCACATATGTCCCATGC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CAACTTGGTTGCTTTGG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09399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yma.13G323800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TCGTTGGCGACGTTTGT</a:t>
                      </a:r>
                      <a:r>
                        <a:rPr lang="en-US" sz="1000" b="1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TCCCATTCGCAAGCCCTA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77417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1578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9D5B157-2480-41CE-A40C-1EE206F78D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8527" y="0"/>
            <a:ext cx="5886156" cy="588615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D3DA5A8-FA5C-497B-98C7-DA857E945043}"/>
              </a:ext>
            </a:extLst>
          </p:cNvPr>
          <p:cNvSpPr txBox="1"/>
          <p:nvPr/>
        </p:nvSpPr>
        <p:spPr>
          <a:xfrm>
            <a:off x="1554352" y="5886156"/>
            <a:ext cx="9952883" cy="608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Principal Component Analysis (PCA) of the similarities and differences between the twelve samples used for RNA-Sequencing in </a:t>
            </a:r>
            <a:r>
              <a:rPr kumimoji="0" lang="en-US" altLang="zh-CN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ndou</a:t>
            </a: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21(JD) and Tianlong 1 (N1) under drought stress.</a:t>
            </a: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9B6B98E-B257-4550-A37A-31A548AB46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7349" y="1105636"/>
            <a:ext cx="928694" cy="1180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91986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63D1C20E-B1E8-4F28-A697-CA34111BD969}"/>
              </a:ext>
            </a:extLst>
          </p:cNvPr>
          <p:cNvSpPr/>
          <p:nvPr/>
        </p:nvSpPr>
        <p:spPr>
          <a:xfrm>
            <a:off x="1248306" y="6227403"/>
            <a:ext cx="10182813" cy="3847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Ontology classification of </a:t>
            </a:r>
            <a:r>
              <a:rPr kumimoji="0" lang="zh-CN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wo </a:t>
            </a:r>
            <a:r>
              <a:rPr kumimoji="0" lang="zh-CN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oybean </a:t>
            </a: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otypes.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ntology classification of DEGs in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rought sensitive soybean N1. (B) </a:t>
            </a:r>
            <a:r>
              <a: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ntology classification of DEGs in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rought tolerant soybean JD. X-axis indicates GO terms, while the Y-axis indicates the percentage and number of DGEs.</a:t>
            </a:r>
            <a:r>
              <a: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B955B744-3E78-4810-A5FF-5866879F09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7667" y="136035"/>
            <a:ext cx="6078544" cy="6091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55494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6A1934BB-9D5D-45FE-A728-90A0FC3403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6608249"/>
              </p:ext>
            </p:extLst>
          </p:nvPr>
        </p:nvGraphicFramePr>
        <p:xfrm>
          <a:off x="2785056" y="574718"/>
          <a:ext cx="6621887" cy="41244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43A970A2-53B2-42B0-8538-E6C3303E4C5C}"/>
              </a:ext>
            </a:extLst>
          </p:cNvPr>
          <p:cNvSpPr/>
          <p:nvPr/>
        </p:nvSpPr>
        <p:spPr>
          <a:xfrm>
            <a:off x="1095644" y="5369672"/>
            <a:ext cx="10182813" cy="5309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 . Validation of RNA-seq expression data by </a:t>
            </a:r>
            <a:r>
              <a:rPr kumimoji="0" lang="en-US" altLang="zh-CN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PCR analysis. </a:t>
            </a:r>
            <a:r>
              <a:rPr kumimoji="0" lang="en-US" altLang="zh-CN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alidation was performed using 16 randomly selected differentially expressed genes (DEGs). The blue plots demonstrate relative expression level in log</a:t>
            </a:r>
            <a:r>
              <a:rPr kumimoji="0" lang="en-US" altLang="zh-CN" sz="100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C values with base of two methods. FC represents the expression level fold change of genes in two soybean genotypes after drought treatment. The X-axis indicates RNA-seq in log</a:t>
            </a:r>
            <a:r>
              <a:rPr kumimoji="0" lang="en-US" altLang="zh-CN" sz="100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C values ; the Y-axis indicates </a:t>
            </a:r>
            <a:r>
              <a:rPr kumimoji="0" lang="en-US" altLang="zh-CN" sz="10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kumimoji="0" lang="en-US" altLang="zh-CN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PCR in log</a:t>
            </a:r>
            <a:r>
              <a:rPr kumimoji="0" lang="en-US" altLang="zh-CN" sz="100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C values.</a:t>
            </a:r>
          </a:p>
        </p:txBody>
      </p:sp>
    </p:spTree>
    <p:extLst>
      <p:ext uri="{BB962C8B-B14F-4D97-AF65-F5344CB8AC3E}">
        <p14:creationId xmlns:p14="http://schemas.microsoft.com/office/powerpoint/2010/main" val="15355905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21DA8CFE-8183-4CB5-927C-AE20220CA8AD}"/>
              </a:ext>
            </a:extLst>
          </p:cNvPr>
          <p:cNvSpPr txBox="1"/>
          <p:nvPr/>
        </p:nvSpPr>
        <p:spPr>
          <a:xfrm>
            <a:off x="1084873" y="5987664"/>
            <a:ext cx="9435490" cy="5309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. The phytohormone signaling pathways and heatmap of related DEGs.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-D represent the signal transduction pathways of ABA, ET, AUX, SA and the heatmap of DEGs enriched in each pathway , respectively. The log</a:t>
            </a:r>
            <a:r>
              <a:rPr kumimoji="0" lang="en-US" altLang="zh-CN" sz="10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C was colored using Microsoft Office Excel 2019 ( red for up-regulated, green for down-regulated).The horizontal row represents a DEG with its gene ID, and the vertical columns represent </a:t>
            </a:r>
            <a:r>
              <a:rPr kumimoji="0" lang="pt-BR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_N1 vs CK_N1 and d_JD vs CK_JD from left to right.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315E6E5-2CF4-40AE-A74D-154AEC9DC2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8503" y="266456"/>
            <a:ext cx="6625654" cy="5616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80258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B3A3ACE-38B3-4E86-ABEC-586255B43BE9}"/>
              </a:ext>
            </a:extLst>
          </p:cNvPr>
          <p:cNvSpPr txBox="1"/>
          <p:nvPr/>
        </p:nvSpPr>
        <p:spPr>
          <a:xfrm>
            <a:off x="2560682" y="6202512"/>
            <a:ext cx="7683456" cy="5309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5. Heatmap of differentially expressed PMEs and XTHs related to cell wall synthesis and remodeling.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log</a:t>
            </a:r>
            <a:r>
              <a:rPr kumimoji="0" lang="en-US" altLang="zh-CN" sz="10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C was colored using Microsoft Office Excel 2019 ( red for up-regulated, green for down-regulated). The horizontal row represents a DEG with its gene ID, and the vertical columns represent d_N1 vs CK_N1 and 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_JD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vs CK_JD from left to right. 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D2778A0-00BE-49E5-A3AE-C25935FB94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2832" y="0"/>
            <a:ext cx="3513500" cy="6265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45911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74CAB7B5-E258-4C20-A76E-0F2F279BF93C}"/>
              </a:ext>
            </a:extLst>
          </p:cNvPr>
          <p:cNvSpPr txBox="1"/>
          <p:nvPr/>
        </p:nvSpPr>
        <p:spPr>
          <a:xfrm>
            <a:off x="2633411" y="663191"/>
            <a:ext cx="609399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900" b="1" kern="10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 S1.</a:t>
            </a:r>
            <a:r>
              <a:rPr lang="zh-CN" altLang="en-US" sz="900" b="1" kern="10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b="1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equencing data quality preprocessing results.</a:t>
            </a:r>
            <a:endParaRPr lang="zh-CN" altLang="zh-CN" sz="900" b="1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1F379BDF-1835-4DCF-A553-0EC897D5CC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9721617"/>
              </p:ext>
            </p:extLst>
          </p:nvPr>
        </p:nvGraphicFramePr>
        <p:xfrm>
          <a:off x="2756836" y="1055230"/>
          <a:ext cx="6453839" cy="3194050"/>
        </p:xfrm>
        <a:graphic>
          <a:graphicData uri="http://schemas.openxmlformats.org/drawingml/2006/table">
            <a:tbl>
              <a:tblPr firstRow="1" firstCol="1" bandRow="1"/>
              <a:tblGrid>
                <a:gridCol w="986489">
                  <a:extLst>
                    <a:ext uri="{9D8B030D-6E8A-4147-A177-3AD203B41FA5}">
                      <a16:colId xmlns:a16="http://schemas.microsoft.com/office/drawing/2014/main" val="3267898814"/>
                    </a:ext>
                  </a:extLst>
                </a:gridCol>
                <a:gridCol w="1100138">
                  <a:extLst>
                    <a:ext uri="{9D8B030D-6E8A-4147-A177-3AD203B41FA5}">
                      <a16:colId xmlns:a16="http://schemas.microsoft.com/office/drawing/2014/main" val="4145367700"/>
                    </a:ext>
                  </a:extLst>
                </a:gridCol>
                <a:gridCol w="1238250">
                  <a:extLst>
                    <a:ext uri="{9D8B030D-6E8A-4147-A177-3AD203B41FA5}">
                      <a16:colId xmlns:a16="http://schemas.microsoft.com/office/drawing/2014/main" val="1410167548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1587200569"/>
                    </a:ext>
                  </a:extLst>
                </a:gridCol>
                <a:gridCol w="1109662">
                  <a:extLst>
                    <a:ext uri="{9D8B030D-6E8A-4147-A177-3AD203B41FA5}">
                      <a16:colId xmlns:a16="http://schemas.microsoft.com/office/drawing/2014/main" val="442278158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965162129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ple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aw </a:t>
                      </a: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ases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G)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lean </a:t>
                      </a: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ases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G)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alid </a:t>
                      </a: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ases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30</a:t>
                      </a:r>
                      <a:r>
                        <a:rPr lang="en-US" sz="1000" b="1" kern="100" baseline="300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8425698"/>
                  </a:ext>
                </a:extLst>
              </a:tr>
              <a:tr h="2425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44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7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5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601651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88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2.8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1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5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3975284"/>
                  </a:ext>
                </a:extLst>
              </a:tr>
              <a:tr h="2425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3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30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4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9950807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2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4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94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531487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2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37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9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60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8366631"/>
                  </a:ext>
                </a:extLst>
              </a:tr>
              <a:tr h="2425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3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0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85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085194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4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8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75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2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1819263"/>
                  </a:ext>
                </a:extLst>
              </a:tr>
              <a:tr h="2425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20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69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15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658858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3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54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86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15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28977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2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30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4505332"/>
                  </a:ext>
                </a:extLst>
              </a:tr>
              <a:tr h="24257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93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4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.79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29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6730516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3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.4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87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2.64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2.94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.85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3451981"/>
                  </a:ext>
                </a:extLst>
              </a:tr>
            </a:tbl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B6822974-A815-44D1-BF91-354E32DA1EE5}"/>
              </a:ext>
            </a:extLst>
          </p:cNvPr>
          <p:cNvSpPr txBox="1"/>
          <p:nvPr/>
        </p:nvSpPr>
        <p:spPr>
          <a:xfrm>
            <a:off x="2756836" y="4249280"/>
            <a:ext cx="6093994" cy="10310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kern="100" spc="75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number of original sequencing bases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9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 The amount of sequencing bases after filtering .</a:t>
            </a:r>
            <a:endParaRPr lang="zh-CN" altLang="zh-CN" sz="900" kern="100" dirty="0"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The ratio of bases between the clean and the raw bases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 The percentage of raw bases with a </a:t>
            </a:r>
            <a:r>
              <a:rPr lang="en-US" altLang="zh-CN" sz="900" kern="100" dirty="0" err="1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red</a:t>
            </a:r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value &gt; 30 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The total number of G and C in clean bases as a percentage of the total number of bases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06460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C10A7542-1995-4512-9CE8-185D5B907BED}"/>
              </a:ext>
            </a:extLst>
          </p:cNvPr>
          <p:cNvSpPr txBox="1"/>
          <p:nvPr/>
        </p:nvSpPr>
        <p:spPr>
          <a:xfrm>
            <a:off x="2697579" y="1022766"/>
            <a:ext cx="852162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</a:rPr>
              <a:t>Table S2</a:t>
            </a:r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900" b="1" dirty="0">
                <a:effectLst/>
                <a:latin typeface="Palatino Linotype" panose="02040502050505030304" pitchFamily="18" charset="0"/>
                <a:ea typeface="等线" panose="02010600030101010101" pitchFamily="2" charset="-122"/>
              </a:rPr>
              <a:t>Statistical results of comparison rate with reference genome.</a:t>
            </a:r>
            <a:endParaRPr lang="zh-CN" altLang="en-US" sz="1400" b="1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6CD10B3-0AF2-4CEB-8639-22D2D0B405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7967730"/>
              </p:ext>
            </p:extLst>
          </p:nvPr>
        </p:nvGraphicFramePr>
        <p:xfrm>
          <a:off x="2788252" y="1396097"/>
          <a:ext cx="5884261" cy="2668911"/>
        </p:xfrm>
        <a:graphic>
          <a:graphicData uri="http://schemas.openxmlformats.org/drawingml/2006/table">
            <a:tbl>
              <a:tblPr firstRow="1" firstCol="1" bandRow="1"/>
              <a:tblGrid>
                <a:gridCol w="1046292">
                  <a:extLst>
                    <a:ext uri="{9D8B030D-6E8A-4147-A177-3AD203B41FA5}">
                      <a16:colId xmlns:a16="http://schemas.microsoft.com/office/drawing/2014/main" val="265411859"/>
                    </a:ext>
                  </a:extLst>
                </a:gridCol>
                <a:gridCol w="1157301">
                  <a:extLst>
                    <a:ext uri="{9D8B030D-6E8A-4147-A177-3AD203B41FA5}">
                      <a16:colId xmlns:a16="http://schemas.microsoft.com/office/drawing/2014/main" val="1420450231"/>
                    </a:ext>
                  </a:extLst>
                </a:gridCol>
                <a:gridCol w="1411452">
                  <a:extLst>
                    <a:ext uri="{9D8B030D-6E8A-4147-A177-3AD203B41FA5}">
                      <a16:colId xmlns:a16="http://schemas.microsoft.com/office/drawing/2014/main" val="1258194756"/>
                    </a:ext>
                  </a:extLst>
                </a:gridCol>
                <a:gridCol w="2269216">
                  <a:extLst>
                    <a:ext uri="{9D8B030D-6E8A-4147-A177-3AD203B41FA5}">
                      <a16:colId xmlns:a16="http://schemas.microsoft.com/office/drawing/2014/main" val="37706781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ple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ads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otal mapped </a:t>
                      </a: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ads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atio (total mapped /total)</a:t>
                      </a:r>
                      <a:r>
                        <a:rPr lang="en-US" sz="1000" b="1" kern="100" baseline="300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zh-CN" altLang="en-US" sz="1000" b="1" kern="100" baseline="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%</a:t>
                      </a:r>
                      <a:r>
                        <a:rPr lang="zh-CN" alt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4203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1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405802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860505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74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3581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2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182188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602325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65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7704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_3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410300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778951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56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60771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1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355778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613420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3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7733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445356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665518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25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53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N1_3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511258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011630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84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6064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1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552384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961433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6.65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98325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483976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299243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.50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5766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_3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531664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256408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.32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241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1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357494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10658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.36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97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491832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6149653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.17</a:t>
                      </a:r>
                      <a:endParaRPr lang="zh-CN" sz="1000" b="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5500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_3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110716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814632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7.25</a:t>
                      </a:r>
                      <a:endParaRPr lang="zh-CN" sz="1000" b="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1539948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557236E7-07D1-4492-992F-522403D063F9}"/>
              </a:ext>
            </a:extLst>
          </p:cNvPr>
          <p:cNvSpPr txBox="1"/>
          <p:nvPr/>
        </p:nvSpPr>
        <p:spPr>
          <a:xfrm>
            <a:off x="2788252" y="4065008"/>
            <a:ext cx="6093994" cy="4870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</a:pPr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 The number of sequencing sequences filtered by sequencing data (Clean reads)</a:t>
            </a:r>
            <a:r>
              <a:rPr lang="en-US" altLang="zh-CN" sz="9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95000"/>
              </a:lnSpc>
            </a:pPr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 The number of sequencing sequences that can be located on the genome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95000"/>
              </a:lnSpc>
            </a:pPr>
            <a:r>
              <a:rPr lang="en-US" altLang="zh-CN" sz="900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The ratio of reads between the total mapped and the total reads.</a:t>
            </a:r>
            <a:endParaRPr lang="zh-CN" altLang="zh-CN" sz="900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33114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6F7299E-7397-4130-A1D3-D17D03CEFDAE}"/>
              </a:ext>
            </a:extLst>
          </p:cNvPr>
          <p:cNvSpPr txBox="1"/>
          <p:nvPr/>
        </p:nvSpPr>
        <p:spPr>
          <a:xfrm>
            <a:off x="2656842" y="1124900"/>
            <a:ext cx="754358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900" b="1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</a:rPr>
              <a:t>Table</a:t>
            </a:r>
            <a:r>
              <a:rPr lang="en-US" altLang="zh-CN" sz="900" b="1" kern="10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3. </a:t>
            </a:r>
            <a:r>
              <a:rPr lang="en-US" altLang="zh-CN" sz="900" b="1" kern="1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rought-stress-responsive DEGs annotated to different databases.</a:t>
            </a:r>
            <a:endParaRPr lang="zh-CN" altLang="zh-CN" sz="900" b="1" kern="100" dirty="0"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14277D4E-F2C0-4411-979E-A152E94A6B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2586505"/>
              </p:ext>
            </p:extLst>
          </p:nvPr>
        </p:nvGraphicFramePr>
        <p:xfrm>
          <a:off x="2782324" y="1513467"/>
          <a:ext cx="5366956" cy="1046841"/>
        </p:xfrm>
        <a:graphic>
          <a:graphicData uri="http://schemas.openxmlformats.org/drawingml/2006/table">
            <a:tbl>
              <a:tblPr firstRow="1" firstCol="1" bandRow="1"/>
              <a:tblGrid>
                <a:gridCol w="1341739">
                  <a:extLst>
                    <a:ext uri="{9D8B030D-6E8A-4147-A177-3AD203B41FA5}">
                      <a16:colId xmlns:a16="http://schemas.microsoft.com/office/drawing/2014/main" val="3191779716"/>
                    </a:ext>
                  </a:extLst>
                </a:gridCol>
                <a:gridCol w="1341739">
                  <a:extLst>
                    <a:ext uri="{9D8B030D-6E8A-4147-A177-3AD203B41FA5}">
                      <a16:colId xmlns:a16="http://schemas.microsoft.com/office/drawing/2014/main" val="565343529"/>
                    </a:ext>
                  </a:extLst>
                </a:gridCol>
                <a:gridCol w="1341739">
                  <a:extLst>
                    <a:ext uri="{9D8B030D-6E8A-4147-A177-3AD203B41FA5}">
                      <a16:colId xmlns:a16="http://schemas.microsoft.com/office/drawing/2014/main" val="3560338163"/>
                    </a:ext>
                  </a:extLst>
                </a:gridCol>
                <a:gridCol w="1341739">
                  <a:extLst>
                    <a:ext uri="{9D8B030D-6E8A-4147-A177-3AD203B41FA5}">
                      <a16:colId xmlns:a16="http://schemas.microsoft.com/office/drawing/2014/main" val="294001677"/>
                    </a:ext>
                  </a:extLst>
                </a:gridCol>
              </a:tblGrid>
              <a:tr h="2256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EG set</a:t>
                      </a:r>
                      <a:endParaRPr lang="zh-CN" sz="1000" b="1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zh-CN" sz="1000" b="1" kern="100" baseline="300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O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zh-CN" sz="1000" b="1" kern="100" baseline="300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b="1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EGG</a:t>
                      </a:r>
                      <a:r>
                        <a:rPr lang="en-US" sz="1000" b="1" kern="100" baseline="300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zh-CN" sz="1000" b="1" kern="100" baseline="300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0519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 vs CK_JD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038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069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07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8282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N1vs CK_N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12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86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94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82903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K_JD vs CK_N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49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108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6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3629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 err="1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_JD</a:t>
                      </a: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vs d_N1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95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02</a:t>
                      </a:r>
                      <a:endParaRPr lang="zh-CN" sz="1000" kern="10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000" kern="100" dirty="0">
                          <a:effectLst/>
                          <a:latin typeface="Palatino Linotype" panose="0204050205050503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08</a:t>
                      </a:r>
                      <a:endParaRPr lang="zh-CN" sz="1000" kern="100" dirty="0">
                        <a:effectLst/>
                        <a:latin typeface="Palatino Linotype" panose="0204050205050503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1885335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ADF56AAC-B618-4B98-98DE-17A5B93A171E}"/>
              </a:ext>
            </a:extLst>
          </p:cNvPr>
          <p:cNvSpPr txBox="1"/>
          <p:nvPr/>
        </p:nvSpPr>
        <p:spPr>
          <a:xfrm>
            <a:off x="2782324" y="2560308"/>
            <a:ext cx="6096000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9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 The total number of DEGs.</a:t>
            </a:r>
            <a:endParaRPr kumimoji="0" lang="zh-CN" altLang="zh-CN" sz="9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9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 The number of DEGs enriched in GO term.</a:t>
            </a:r>
            <a:endParaRPr kumimoji="0" lang="zh-CN" altLang="zh-CN" sz="9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9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The number of DEGs enriched in KEGG pathway.</a:t>
            </a:r>
            <a:endParaRPr kumimoji="0" lang="zh-CN" altLang="zh-CN" sz="9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925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98</TotalTime>
  <Words>919</Words>
  <Application>Microsoft Office PowerPoint</Application>
  <PresentationFormat>宽屏</PresentationFormat>
  <Paragraphs>214</Paragraphs>
  <Slides>10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6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an huidong</dc:creator>
  <cp:lastModifiedBy>xuan huidong</cp:lastModifiedBy>
  <cp:revision>76</cp:revision>
  <dcterms:created xsi:type="dcterms:W3CDTF">2021-12-22T08:25:06Z</dcterms:created>
  <dcterms:modified xsi:type="dcterms:W3CDTF">2022-03-07T02:07:25Z</dcterms:modified>
</cp:coreProperties>
</file>